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92" r:id="rId2"/>
  </p:sldIdLst>
  <p:sldSz cx="6858000" cy="9144000" type="screen4x3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 autoAdjust="0"/>
    <p:restoredTop sz="94676" autoAdjust="0"/>
  </p:normalViewPr>
  <p:slideViewPr>
    <p:cSldViewPr>
      <p:cViewPr>
        <p:scale>
          <a:sx n="200" d="100"/>
          <a:sy n="200" d="100"/>
        </p:scale>
        <p:origin x="1080" y="75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E555D-ECA8-4B05-BB7B-46DB13C02D3B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A6C07-1ED5-48E5-9F9F-17C16A106B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3203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09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527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93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105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312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25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67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67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94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384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97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40B43-3877-4D1A-B370-5D57BA53EA63}" type="datetimeFigureOut">
              <a:rPr lang="en-GB" smtClean="0"/>
              <a:t>07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861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32656" y="755576"/>
            <a:ext cx="61926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/>
              <a:t>Supplementary Table 1: Biomass traits in a Miscanthus population (a) and a mapping family (b).  The population consisted of </a:t>
            </a:r>
            <a:r>
              <a:rPr lang="en-GB" sz="1200" i="1" dirty="0" smtClean="0"/>
              <a:t>M. sinensis </a:t>
            </a:r>
            <a:r>
              <a:rPr lang="en-GB" sz="1200" dirty="0" smtClean="0"/>
              <a:t>(Sin), Hybrids (</a:t>
            </a:r>
            <a:r>
              <a:rPr lang="en-GB" sz="1200" dirty="0" err="1" smtClean="0"/>
              <a:t>Hyb</a:t>
            </a:r>
            <a:r>
              <a:rPr lang="en-GB" sz="1200" dirty="0" smtClean="0"/>
              <a:t>) and </a:t>
            </a:r>
            <a:r>
              <a:rPr lang="en-GB" sz="1200" i="1" dirty="0" smtClean="0"/>
              <a:t>M. sacchariflorus </a:t>
            </a:r>
            <a:r>
              <a:rPr lang="en-GB" sz="1200" dirty="0" smtClean="0"/>
              <a:t>(Sac) and the mapping family were all hybrids (</a:t>
            </a:r>
            <a:r>
              <a:rPr lang="en-GB" sz="1200" i="1" dirty="0" smtClean="0"/>
              <a:t>M. sacchariflorus </a:t>
            </a:r>
            <a:r>
              <a:rPr lang="en-GB" sz="1200" dirty="0" smtClean="0"/>
              <a:t>x </a:t>
            </a:r>
            <a:r>
              <a:rPr lang="en-GB" sz="1200" i="1" dirty="0" smtClean="0"/>
              <a:t>M. sinensis</a:t>
            </a:r>
            <a:r>
              <a:rPr lang="en-GB" sz="1200" dirty="0" smtClean="0"/>
              <a:t>) except a single </a:t>
            </a:r>
            <a:r>
              <a:rPr lang="en-GB" sz="1200" i="1" dirty="0" smtClean="0"/>
              <a:t>M. sinensis </a:t>
            </a:r>
            <a:r>
              <a:rPr lang="en-GB" sz="1200" dirty="0" smtClean="0"/>
              <a:t>genotype, Goliath. Statistics show differences between genotypes from ANOVA (P=≤0.05</a:t>
            </a:r>
            <a:r>
              <a:rPr lang="en-GB" sz="1200" dirty="0"/>
              <a:t>). N=3, ± </a:t>
            </a:r>
            <a:r>
              <a:rPr lang="en-GB" sz="1200" dirty="0" smtClean="0"/>
              <a:t>SE.</a:t>
            </a:r>
            <a:r>
              <a:rPr lang="en-GB" sz="1200" dirty="0" smtClean="0"/>
              <a:t> The “T” or “S” after the height value denotes whether a genotype was classified as “Tall” or “Short”.</a:t>
            </a:r>
            <a:endParaRPr lang="en-GB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124744" y="212372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1124744" y="507605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8202070"/>
              </p:ext>
            </p:extLst>
          </p:nvPr>
        </p:nvGraphicFramePr>
        <p:xfrm>
          <a:off x="1930915" y="2133597"/>
          <a:ext cx="3154269" cy="6034095"/>
        </p:xfrm>
        <a:graphic>
          <a:graphicData uri="http://schemas.openxmlformats.org/drawingml/2006/table">
            <a:tbl>
              <a:tblPr/>
              <a:tblGrid>
                <a:gridCol w="638528"/>
                <a:gridCol w="417499"/>
                <a:gridCol w="485036"/>
                <a:gridCol w="98235"/>
                <a:gridCol w="290835"/>
                <a:gridCol w="145083"/>
                <a:gridCol w="98235"/>
                <a:gridCol w="260738"/>
                <a:gridCol w="328672"/>
                <a:gridCol w="98235"/>
                <a:gridCol w="293173"/>
              </a:tblGrid>
              <a:tr h="3303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opulation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typ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oidy </a:t>
                      </a:r>
                      <a:r>
                        <a:rPr lang="en-GB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ight                        (cm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owth rate      (cm d</a:t>
                      </a:r>
                      <a:r>
                        <a:rPr lang="en-GB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nual Yield Harvest (kg plant</a:t>
                      </a:r>
                      <a:r>
                        <a:rPr lang="en-GB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7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9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4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6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5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5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2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7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8</a:t>
                      </a:r>
                      <a:r>
                        <a:rPr lang="en-GB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8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 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9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8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213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</a:t>
                      </a:r>
                      <a:r>
                        <a:rPr lang="en-GB" sz="7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</a:t>
                      </a:r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2426">
                <a:tc>
                  <a:txBody>
                    <a:bodyPr/>
                    <a:lstStyle/>
                    <a:p>
                      <a:pPr algn="l" fontAlgn="b"/>
                      <a:endParaRPr lang="en-GB" sz="7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8381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ping Family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typ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oidy </a:t>
                      </a:r>
                      <a:r>
                        <a:rPr lang="en-GB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ight                        (cm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owth rate      (cm d</a:t>
                      </a:r>
                      <a:r>
                        <a:rPr lang="en-GB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nual Yield Harvest (kg plant</a:t>
                      </a:r>
                      <a:r>
                        <a:rPr lang="en-GB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oliath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6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5 </a:t>
                      </a:r>
                      <a:r>
                        <a:rPr lang="en-GB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7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3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0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8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   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T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6140" marR="6140" marT="614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6140" marR="6140" marT="614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9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</a:t>
                      </a:r>
                      <a:r>
                        <a:rPr lang="en-GB" sz="7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</a:t>
                      </a:r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6140" marR="6140" marT="61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8969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78</TotalTime>
  <Words>745</Words>
  <Application>Microsoft Office PowerPoint</Application>
  <PresentationFormat>On-screen Show (4:3)</PresentationFormat>
  <Paragraphs>4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berystwyth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p</dc:creator>
  <cp:lastModifiedBy>sap</cp:lastModifiedBy>
  <cp:revision>84</cp:revision>
  <cp:lastPrinted>2015-03-27T09:20:34Z</cp:lastPrinted>
  <dcterms:created xsi:type="dcterms:W3CDTF">2014-04-04T15:40:13Z</dcterms:created>
  <dcterms:modified xsi:type="dcterms:W3CDTF">2015-09-07T13:24:30Z</dcterms:modified>
</cp:coreProperties>
</file>